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93455" r:id="rId4"/>
  </p:sldMasterIdLst>
  <p:notesMasterIdLst>
    <p:notesMasterId r:id="rId19"/>
  </p:notesMasterIdLst>
  <p:sldIdLst>
    <p:sldId id="310" r:id="rId5"/>
    <p:sldId id="314" r:id="rId6"/>
    <p:sldId id="311" r:id="rId7"/>
    <p:sldId id="332" r:id="rId8"/>
    <p:sldId id="330" r:id="rId9"/>
    <p:sldId id="331" r:id="rId10"/>
    <p:sldId id="335" r:id="rId11"/>
    <p:sldId id="333" r:id="rId12"/>
    <p:sldId id="334" r:id="rId13"/>
    <p:sldId id="312" r:id="rId14"/>
    <p:sldId id="336" r:id="rId15"/>
    <p:sldId id="339" r:id="rId16"/>
    <p:sldId id="337" r:id="rId17"/>
    <p:sldId id="329" r:id="rId18"/>
  </p:sldIdLst>
  <p:sldSz cx="9144000" cy="5143500" type="screen16x9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orient="horz" pos="3012" userDrawn="1">
          <p15:clr>
            <a:srgbClr val="A4A3A4"/>
          </p15:clr>
        </p15:guide>
        <p15:guide id="3" orient="horz" pos="1620">
          <p15:clr>
            <a:srgbClr val="A4A3A4"/>
          </p15:clr>
        </p15:guide>
        <p15:guide id="4" orient="horz" pos="120">
          <p15:clr>
            <a:srgbClr val="A4A3A4"/>
          </p15:clr>
        </p15:guide>
        <p15:guide id="5" orient="horz" pos="756" userDrawn="1">
          <p15:clr>
            <a:srgbClr val="A4A3A4"/>
          </p15:clr>
        </p15:guide>
        <p15:guide id="6" pos="432">
          <p15:clr>
            <a:srgbClr val="A4A3A4"/>
          </p15:clr>
        </p15:guide>
        <p15:guide id="7" pos="5478">
          <p15:clr>
            <a:srgbClr val="A4A3A4"/>
          </p15:clr>
        </p15:guide>
        <p15:guide id="8" pos="2879">
          <p15:clr>
            <a:srgbClr val="A4A3A4"/>
          </p15:clr>
        </p15:guide>
        <p15:guide id="9" orient="horz" pos="424">
          <p15:clr>
            <a:srgbClr val="A4A3A4"/>
          </p15:clr>
        </p15:guide>
        <p15:guide id="10" pos="4781">
          <p15:clr>
            <a:srgbClr val="A4A3A4"/>
          </p15:clr>
        </p15:guide>
        <p15:guide id="11" pos="5471">
          <p15:clr>
            <a:srgbClr val="A4A3A4"/>
          </p15:clr>
        </p15:guide>
        <p15:guide id="12" pos="42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D2D2D"/>
    <a:srgbClr val="EDEDEB"/>
    <a:srgbClr val="DBD6D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55C230E-F4FC-41C8-AADB-6DF1A98D333A}" v="4" dt="2021-03-12T16:52:39.207"/>
    <p1510:client id="{E1EAB17D-2A68-41F1-A048-7DB8253D71C7}" v="104" dt="2021-03-12T16:18:21.73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730" autoAdjust="0"/>
    <p:restoredTop sz="94694"/>
  </p:normalViewPr>
  <p:slideViewPr>
    <p:cSldViewPr snapToGrid="0" snapToObjects="1">
      <p:cViewPr varScale="1">
        <p:scale>
          <a:sx n="156" d="100"/>
          <a:sy n="156" d="100"/>
        </p:scale>
        <p:origin x="928" y="168"/>
      </p:cViewPr>
      <p:guideLst>
        <p:guide orient="horz" pos="3012"/>
        <p:guide orient="horz" pos="1620"/>
        <p:guide orient="horz" pos="120"/>
        <p:guide orient="horz" pos="756"/>
        <p:guide pos="432"/>
        <p:guide pos="5478"/>
        <p:guide pos="2879"/>
        <p:guide orient="horz" pos="424"/>
        <p:guide pos="4781"/>
        <p:guide pos="5471"/>
        <p:guide pos="426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49" d="100"/>
        <a:sy n="149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3" Type="http://schemas.openxmlformats.org/officeDocument/2006/relationships/customXml" Target="../customXml/item3.xml"/><Relationship Id="rId21" Type="http://schemas.openxmlformats.org/officeDocument/2006/relationships/viewProps" Target="viewProp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presProps" Target="pres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microsoft.com/office/2015/10/relationships/revisionInfo" Target="revisionInfo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tableStyles" Target="tableStyles.xml"/><Relationship Id="rId10" Type="http://schemas.openxmlformats.org/officeDocument/2006/relationships/slide" Target="slides/slide6.xml"/><Relationship Id="rId19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42E0F2-B694-C44C-A396-27B6C59A926F}" type="datetimeFigureOut">
              <a:rPr lang="en-US" smtClean="0"/>
              <a:t>4/1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E6F44A-B88D-2946-8FFA-91DB132F0E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1495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1315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0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379933"/>
            <a:ext cx="5943600" cy="1859909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4375153"/>
            <a:ext cx="5943600" cy="576072"/>
          </a:xfrm>
        </p:spPr>
        <p:txBody>
          <a:bodyPr>
            <a:normAutofit/>
          </a:bodyPr>
          <a:lstStyle>
            <a:lvl1pPr marL="0" indent="0" algn="l">
              <a:lnSpc>
                <a:spcPct val="125000"/>
              </a:lnSpc>
              <a:spcBef>
                <a:spcPts val="0"/>
              </a:spcBef>
              <a:buNone/>
              <a:defRPr sz="1400" baseline="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20" name="Text Placeholder 10"/>
          <p:cNvSpPr>
            <a:spLocks noGrp="1"/>
          </p:cNvSpPr>
          <p:nvPr>
            <p:ph type="body" sz="quarter" idx="10" hasCustomPrompt="1"/>
          </p:nvPr>
        </p:nvSpPr>
        <p:spPr>
          <a:xfrm>
            <a:off x="685800" y="3393851"/>
            <a:ext cx="5943600" cy="509588"/>
          </a:xfrm>
        </p:spPr>
        <p:txBody>
          <a:bodyPr>
            <a:normAutofit/>
          </a:bodyPr>
          <a:lstStyle>
            <a:lvl1pPr indent="0">
              <a:lnSpc>
                <a:spcPct val="90000"/>
              </a:lnSpc>
              <a:spcBef>
                <a:spcPts val="0"/>
              </a:spcBef>
              <a:buFontTx/>
              <a:buNone/>
              <a:defRPr sz="1600" b="1" i="0" cap="all" baseline="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Insert subheading here if needed</a:t>
            </a:r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2" y="466344"/>
            <a:ext cx="4116387" cy="561684"/>
          </a:xfrm>
        </p:spPr>
        <p:txBody>
          <a:bodyPr>
            <a:normAutofit/>
          </a:bodyPr>
          <a:lstStyle>
            <a:lvl1pPr algn="r">
              <a:lnSpc>
                <a:spcPct val="125000"/>
              </a:lnSpc>
              <a:spcBef>
                <a:spcPts val="0"/>
              </a:spcBef>
              <a:defRPr sz="140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303091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0322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B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2714558"/>
            <a:ext cx="6904037" cy="4606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2571464"/>
          </a:xfrm>
          <a:custGeom>
            <a:avLst/>
            <a:gdLst/>
            <a:ahLst/>
            <a:cxnLst/>
            <a:rect l="l" t="t" r="r" b="b"/>
            <a:pathLst>
              <a:path w="9144000" h="2571464">
                <a:moveTo>
                  <a:pt x="0" y="0"/>
                </a:moveTo>
                <a:lnTo>
                  <a:pt x="9144000" y="0"/>
                </a:lnTo>
                <a:lnTo>
                  <a:pt x="9144000" y="2341563"/>
                </a:lnTo>
                <a:lnTo>
                  <a:pt x="937943" y="2341563"/>
                </a:lnTo>
                <a:lnTo>
                  <a:pt x="838395" y="2547225"/>
                </a:lnTo>
                <a:cubicBezTo>
                  <a:pt x="822041" y="2580435"/>
                  <a:pt x="801198" y="2578640"/>
                  <a:pt x="786640" y="2547225"/>
                </a:cubicBezTo>
                <a:lnTo>
                  <a:pt x="687092" y="2341563"/>
                </a:lnTo>
                <a:lnTo>
                  <a:pt x="0" y="2341563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5"/>
          </p:nvPr>
        </p:nvSpPr>
        <p:spPr>
          <a:xfrm>
            <a:off x="685800" y="3300413"/>
            <a:ext cx="6904038" cy="13716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0746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icture with Caption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4314599"/>
            <a:ext cx="6904038" cy="409158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3" name="Picture Placeholder 5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8275"/>
                </a:lnTo>
                <a:lnTo>
                  <a:pt x="938928" y="3978275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6107" y="3978275"/>
                </a:lnTo>
                <a:lnTo>
                  <a:pt x="0" y="3978275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627585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icture with Caption B"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5"/>
          <p:cNvSpPr>
            <a:spLocks noGrp="1"/>
          </p:cNvSpPr>
          <p:nvPr>
            <p:ph type="pic" sz="quarter" idx="11"/>
          </p:nvPr>
        </p:nvSpPr>
        <p:spPr>
          <a:xfrm>
            <a:off x="0" y="1218054"/>
            <a:ext cx="9144000" cy="3932237"/>
          </a:xfrm>
          <a:custGeom>
            <a:avLst/>
            <a:gdLst/>
            <a:ahLst/>
            <a:cxnLst/>
            <a:rect l="l" t="t" r="r" b="b"/>
            <a:pathLst>
              <a:path w="9144000" h="3932237">
                <a:moveTo>
                  <a:pt x="0" y="0"/>
                </a:moveTo>
                <a:lnTo>
                  <a:pt x="688874" y="0"/>
                </a:lnTo>
                <a:lnTo>
                  <a:pt x="786640" y="201981"/>
                </a:lnTo>
                <a:cubicBezTo>
                  <a:pt x="801198" y="233396"/>
                  <a:pt x="822041" y="235191"/>
                  <a:pt x="838395" y="201981"/>
                </a:cubicBezTo>
                <a:lnTo>
                  <a:pt x="936161" y="0"/>
                </a:lnTo>
                <a:lnTo>
                  <a:pt x="9144000" y="0"/>
                </a:lnTo>
                <a:lnTo>
                  <a:pt x="9144000" y="3932237"/>
                </a:lnTo>
                <a:lnTo>
                  <a:pt x="0" y="3932237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441137"/>
            <a:ext cx="6904038" cy="694386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pic>
        <p:nvPicPr>
          <p:cNvPr id="9" name="Picture 8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40122"/>
            <a:ext cx="793487" cy="320040"/>
          </a:xfrm>
          <a:prstGeom prst="rect">
            <a:avLst/>
          </a:prstGeom>
        </p:spPr>
      </p:pic>
      <p:sp>
        <p:nvSpPr>
          <p:cNvPr id="14" name="Rectangle 13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9003258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ast Pag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TextBox 5"/>
          <p:cNvSpPr txBox="1"/>
          <p:nvPr userDrawn="1"/>
        </p:nvSpPr>
        <p:spPr>
          <a:xfrm>
            <a:off x="685800" y="1027380"/>
            <a:ext cx="2279959" cy="46166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3000" b="1" i="0" dirty="0">
                <a:solidFill>
                  <a:schemeClr val="bg1"/>
                </a:solidFill>
                <a:latin typeface="+mj-lt"/>
                <a:cs typeface="Arial"/>
              </a:rPr>
              <a:t>THANK YOU</a:t>
            </a:r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4389120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326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 userDrawn="1"/>
        </p:nvSpPr>
        <p:spPr>
          <a:xfrm>
            <a:off x="0" y="0"/>
            <a:ext cx="9144000" cy="51435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1432720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783766"/>
            <a:ext cx="5943600" cy="1869874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3983716"/>
            <a:ext cx="5943600" cy="797834"/>
          </a:xfrm>
        </p:spPr>
        <p:txBody>
          <a:bodyPr anchor="t" anchorCtr="0">
            <a:normAutofit/>
          </a:bodyPr>
          <a:lstStyle>
            <a:lvl1pPr marL="0" indent="0" algn="l">
              <a:spcBef>
                <a:spcPts val="0"/>
              </a:spcBef>
              <a:buNone/>
              <a:defRPr sz="1400" baseline="0">
                <a:solidFill>
                  <a:schemeClr val="bg1"/>
                </a:solidFill>
                <a:latin typeface="+mn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8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2" y="466344"/>
            <a:ext cx="4116387" cy="561684"/>
          </a:xfrm>
        </p:spPr>
        <p:txBody>
          <a:bodyPr>
            <a:normAutofit/>
          </a:bodyPr>
          <a:lstStyle>
            <a:lvl1pPr algn="r">
              <a:spcBef>
                <a:spcPts val="0"/>
              </a:spcBef>
              <a:defRPr sz="1400" baseline="0">
                <a:solidFill>
                  <a:srgbClr val="FFFFFF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11" name="Picture 10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303091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73183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347975"/>
            <a:ext cx="6904038" cy="802243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190935"/>
            <a:ext cx="6904038" cy="351531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39891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964090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084578"/>
            <a:ext cx="6904037" cy="804672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4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946275"/>
            <a:ext cx="6904038" cy="27432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3156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2972870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457200"/>
            <a:ext cx="6904037" cy="1922122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here to write your long headline, quote, or introduction sentence in this space. </a:t>
            </a:r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3062288"/>
            <a:ext cx="6904038" cy="16192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9196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7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377180"/>
            <a:ext cx="8001000" cy="78273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9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8" y="1279780"/>
            <a:ext cx="3811589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0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279780"/>
            <a:ext cx="3813086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sz="quarter" idx="16"/>
          </p:nvPr>
        </p:nvSpPr>
        <p:spPr>
          <a:xfrm>
            <a:off x="685800" y="1755775"/>
            <a:ext cx="3811588" cy="281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Content Placeholder 2"/>
          <p:cNvSpPr>
            <a:spLocks noGrp="1"/>
          </p:cNvSpPr>
          <p:nvPr>
            <p:ph sz="quarter" idx="17"/>
          </p:nvPr>
        </p:nvSpPr>
        <p:spPr>
          <a:xfrm>
            <a:off x="4861946" y="1755775"/>
            <a:ext cx="3811588" cy="281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8520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964090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067180"/>
            <a:ext cx="8001000" cy="78273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1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8" y="1969780"/>
            <a:ext cx="3811589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2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969780"/>
            <a:ext cx="3813086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3"/>
          <p:cNvSpPr>
            <a:spLocks noGrp="1"/>
          </p:cNvSpPr>
          <p:nvPr>
            <p:ph sz="quarter" idx="16"/>
          </p:nvPr>
        </p:nvSpPr>
        <p:spPr>
          <a:xfrm>
            <a:off x="685800" y="2444750"/>
            <a:ext cx="3811588" cy="22145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quarter" idx="17"/>
          </p:nvPr>
        </p:nvSpPr>
        <p:spPr>
          <a:xfrm>
            <a:off x="4873715" y="2444750"/>
            <a:ext cx="3811588" cy="22145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4" name="Picture 13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4827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with Imag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5257800" y="0"/>
            <a:ext cx="3886200" cy="2571750"/>
          </a:xfrm>
          <a:custGeom>
            <a:avLst/>
            <a:gdLst/>
            <a:ahLst/>
            <a:cxnLst/>
            <a:rect l="l" t="t" r="r" b="b"/>
            <a:pathLst>
              <a:path w="3886200" h="2571750">
                <a:moveTo>
                  <a:pt x="0" y="0"/>
                </a:moveTo>
                <a:lnTo>
                  <a:pt x="3886200" y="0"/>
                </a:lnTo>
                <a:lnTo>
                  <a:pt x="3886200" y="2339180"/>
                </a:lnTo>
                <a:lnTo>
                  <a:pt x="506870" y="2339180"/>
                </a:lnTo>
                <a:lnTo>
                  <a:pt x="406031" y="2547511"/>
                </a:lnTo>
                <a:cubicBezTo>
                  <a:pt x="389676" y="2580721"/>
                  <a:pt x="368833" y="2578926"/>
                  <a:pt x="354275" y="2547511"/>
                </a:cubicBezTo>
                <a:lnTo>
                  <a:pt x="253435" y="2339180"/>
                </a:lnTo>
                <a:lnTo>
                  <a:pt x="0" y="2339180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5257800" cy="51435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678487" y="2700906"/>
            <a:ext cx="3008313" cy="624885"/>
          </a:xfrm>
        </p:spPr>
        <p:txBody>
          <a:bodyPr anchor="b">
            <a:normAutofit/>
          </a:bodyPr>
          <a:lstStyle>
            <a:lvl1pPr algn="l">
              <a:lnSpc>
                <a:spcPct val="90000"/>
              </a:lnSpc>
              <a:defRPr sz="1600" b="1" cap="none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5678487" y="3396227"/>
            <a:ext cx="3008313" cy="1318664"/>
          </a:xfrm>
        </p:spPr>
        <p:txBody>
          <a:bodyPr>
            <a:normAutofit/>
          </a:bodyPr>
          <a:lstStyle>
            <a:lvl1pPr marL="0" indent="0">
              <a:buNone/>
              <a:defRPr sz="10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your paragraph here. 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635029"/>
            <a:ext cx="3884612" cy="1292036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0" y="2030413"/>
            <a:ext cx="3884613" cy="2647157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4773168"/>
            <a:ext cx="4187952" cy="27432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8220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/>
          <p:cNvSpPr>
            <a:spLocks noGrp="1"/>
          </p:cNvSpPr>
          <p:nvPr>
            <p:ph type="pic" sz="quarter" idx="18"/>
          </p:nvPr>
        </p:nvSpPr>
        <p:spPr>
          <a:xfrm>
            <a:off x="5257800" y="0"/>
            <a:ext cx="3886200" cy="5143500"/>
          </a:xfrm>
        </p:spPr>
        <p:txBody>
          <a:bodyPr anchor="ctr" anchorCtr="0"/>
          <a:lstStyle>
            <a:lvl1pPr algn="ctr">
              <a:defRPr/>
            </a:lvl1pPr>
          </a:lstStyle>
          <a:p>
            <a:r>
              <a:rPr lang="en-US"/>
              <a:t>Drag picture to placeholder or click icon to add</a:t>
            </a:r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5257800" cy="51435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635029"/>
            <a:ext cx="3884612" cy="1292036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0" y="2030413"/>
            <a:ext cx="3884613" cy="2647157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4773168"/>
            <a:ext cx="4187952" cy="27432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0" name="Picture 9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5255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5800" y="205979"/>
            <a:ext cx="8001000" cy="85725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1200151"/>
            <a:ext cx="8001000" cy="3394472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1069848" y="4773168"/>
            <a:ext cx="6519672" cy="27432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1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5800" y="4773168"/>
            <a:ext cx="310896" cy="27432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0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93843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93505" r:id="rId1"/>
    <p:sldLayoutId id="2147493508" r:id="rId2"/>
    <p:sldLayoutId id="2147493511" r:id="rId3"/>
    <p:sldLayoutId id="2147493468" r:id="rId4"/>
    <p:sldLayoutId id="2147493470" r:id="rId5"/>
    <p:sldLayoutId id="2147493489" r:id="rId6"/>
    <p:sldLayoutId id="2147493471" r:id="rId7"/>
    <p:sldLayoutId id="2147493463" r:id="rId8"/>
    <p:sldLayoutId id="2147493513" r:id="rId9"/>
    <p:sldLayoutId id="2147493474" r:id="rId10"/>
    <p:sldLayoutId id="2147493491" r:id="rId11"/>
    <p:sldLayoutId id="2147493512" r:id="rId12"/>
    <p:sldLayoutId id="2147493483" r:id="rId13"/>
  </p:sldLayoutIdLst>
  <p:hf hdr="0" ftr="0" dt="0"/>
  <p:txStyles>
    <p:titleStyle>
      <a:lvl1pPr algn="l" defTabSz="457200" rtl="0" eaLnBrk="1" latinLnBrk="0" hangingPunct="1">
        <a:lnSpc>
          <a:spcPct val="90000"/>
        </a:lnSpc>
        <a:spcBef>
          <a:spcPct val="0"/>
        </a:spcBef>
        <a:buNone/>
        <a:defRPr sz="3000" b="1" i="0" kern="1200" cap="all" baseline="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0" indent="0" algn="l" defTabSz="457200" rtl="0" eaLnBrk="1" latinLnBrk="0" hangingPunct="1">
        <a:lnSpc>
          <a:spcPct val="125000"/>
        </a:lnSpc>
        <a:spcBef>
          <a:spcPts val="1200"/>
        </a:spcBef>
        <a:buFontTx/>
        <a:buNone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1pPr>
      <a:lvl2pPr marL="502920" indent="-228600" algn="l" defTabSz="457200" rtl="0" eaLnBrk="1" latinLnBrk="0" hangingPunct="1">
        <a:lnSpc>
          <a:spcPct val="125000"/>
        </a:lnSpc>
        <a:spcBef>
          <a:spcPts val="1200"/>
        </a:spcBef>
        <a:buSzPct val="100000"/>
        <a:buFont typeface="Arial"/>
        <a:buChar char="•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2pPr>
      <a:lvl3pPr marL="777240" indent="-228600" algn="l" defTabSz="457200" rtl="0" eaLnBrk="1" latinLnBrk="0" hangingPunct="1">
        <a:lnSpc>
          <a:spcPct val="125000"/>
        </a:lnSpc>
        <a:spcBef>
          <a:spcPts val="1200"/>
        </a:spcBef>
        <a:buFont typeface="Lucida Grande"/>
        <a:buChar char="·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3pPr>
      <a:lvl4pPr marL="11430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–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4pPr>
      <a:lvl5pPr marL="13716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»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uptodate.com/contents/management-of-acute-pancreatitis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AN APPROACH TO pancreatitis in the observation unit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US" dirty="0"/>
              <a:t>Division of Observation Medicin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8B45E81-AE9A-5644-98BD-FDDE7F8197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03538" y="4572703"/>
            <a:ext cx="1422400" cy="4826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F3FDBEE-4533-9B48-9947-BD118D217976}"/>
              </a:ext>
            </a:extLst>
          </p:cNvPr>
          <p:cNvSpPr txBox="1"/>
          <p:nvPr/>
        </p:nvSpPr>
        <p:spPr>
          <a:xfrm>
            <a:off x="9731829" y="3461657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303315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AGNOSI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>
            <a:normAutofit/>
          </a:bodyPr>
          <a:lstStyle/>
          <a:p>
            <a:r>
              <a:rPr lang="en-US" b="1" u="sng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TWO</a:t>
            </a: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 OF THREE CRITERIA MUST BE MET:</a:t>
            </a:r>
          </a:p>
          <a:p>
            <a:r>
              <a:rPr lang="en-US" dirty="0"/>
              <a:t>(1) Epigastric pain radiating to the back.</a:t>
            </a:r>
          </a:p>
          <a:p>
            <a:r>
              <a:rPr lang="en-US" dirty="0"/>
              <a:t>(2) Serum lipase and/or amylase &gt;3X the normal limit. </a:t>
            </a:r>
          </a:p>
          <a:p>
            <a:r>
              <a:rPr lang="en-US" dirty="0"/>
              <a:t>(3) Imaging showing evidence of acute pancreatitis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9317143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FB85F6-03A9-1E43-9B8B-14B9A534DC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EATM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57F575-1133-374C-827B-F475285EDB10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799" y="1530036"/>
            <a:ext cx="7688655" cy="3413155"/>
          </a:xfrm>
        </p:spPr>
        <p:txBody>
          <a:bodyPr numCol="2">
            <a:normAutofit fontScale="70000" lnSpcReduction="20000"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Aggressive IVF hydration </a:t>
            </a:r>
            <a:r>
              <a:rPr lang="en-US" dirty="0">
                <a:solidFill>
                  <a:schemeClr val="bg1"/>
                </a:solidFill>
              </a:rPr>
              <a:t>(a</a:t>
            </a:r>
            <a:r>
              <a:rPr lang="en-US" dirty="0"/>
              <a:t>ssoc. with </a:t>
            </a:r>
            <a:r>
              <a:rPr lang="en-US" b="1" dirty="0"/>
              <a:t>reduction in morbidity &amp; mortality)</a:t>
            </a:r>
            <a:endParaRPr lang="en-US" dirty="0">
              <a:solidFill>
                <a:schemeClr val="accent1">
                  <a:lumMod val="20000"/>
                  <a:lumOff val="80000"/>
                </a:schemeClr>
              </a:solidFill>
            </a:endParaRP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/>
              <a:t>5-10 mL/kg/hr of isotonic crystalloid solution (ie, 0.9% NS or LR solution) </a:t>
            </a:r>
          </a:p>
          <a:p>
            <a:pPr marL="1062990" lvl="2" indent="-285750">
              <a:buFont typeface="Wingdings" pitchFamily="2" charset="2"/>
              <a:buChar char="§"/>
            </a:pPr>
            <a:r>
              <a:rPr lang="en-US" dirty="0"/>
              <a:t>No lactated Ringer’s for patient’s with hypercalcemia</a:t>
            </a:r>
          </a:p>
          <a:p>
            <a:pPr marL="1062990" lvl="2" indent="-285750">
              <a:buFont typeface="Wingdings" pitchFamily="2" charset="2"/>
              <a:buChar char="§"/>
            </a:pPr>
            <a:r>
              <a:rPr lang="en-US" dirty="0"/>
              <a:t>Less aggressive fluid hydration if have, ie, congestive heart failure or chronic kidney diseas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Urine output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1"/>
                </a:solidFill>
              </a:rPr>
              <a:t>Strict I/O’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Diet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1"/>
                </a:solidFill>
              </a:rPr>
              <a:t>Advance diet as tolerated, starting with liquids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/>
              <a:t>Low residue, low fat, soft diet after liquids</a:t>
            </a:r>
            <a:endParaRPr lang="en-US" dirty="0">
              <a:solidFill>
                <a:schemeClr val="bg1"/>
              </a:solidFill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Electrolyte/ Glucose monitoring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1"/>
                </a:solidFill>
              </a:rPr>
              <a:t>Monitor for hypocalcemia and hypomagnesemia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1"/>
                </a:solidFill>
              </a:rPr>
              <a:t>Monitor for hyperglycemia and treat aggressivel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Pain control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1"/>
                </a:solidFill>
              </a:rPr>
              <a:t>Opioids</a:t>
            </a:r>
          </a:p>
          <a:p>
            <a:pPr marL="1062990" lvl="2" indent="-285750">
              <a:buFont typeface="Wingdings" pitchFamily="2" charset="2"/>
              <a:buChar char="§"/>
            </a:pPr>
            <a:r>
              <a:rPr lang="en-US" dirty="0">
                <a:solidFill>
                  <a:schemeClr val="bg1"/>
                </a:solidFill>
                <a:sym typeface="Wingdings" pitchFamily="2" charset="2"/>
              </a:rPr>
              <a:t>IV Dilaudid or IV Fentanyl</a:t>
            </a:r>
          </a:p>
          <a:p>
            <a:pPr marL="1062990" lvl="2" indent="-285750">
              <a:buFont typeface="Wingdings" pitchFamily="2" charset="2"/>
              <a:buChar char="§"/>
            </a:pPr>
            <a:r>
              <a:rPr lang="en-US" dirty="0">
                <a:solidFill>
                  <a:schemeClr val="bg1"/>
                </a:solidFill>
                <a:sym typeface="Wingdings" pitchFamily="2" charset="2"/>
              </a:rPr>
              <a:t>IV M</a:t>
            </a:r>
            <a:r>
              <a:rPr lang="en-US" dirty="0"/>
              <a:t>orphine can be used but was shown to cause an increase in sphincter of Oddi pressur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Oxygen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1"/>
                </a:solidFill>
              </a:rPr>
              <a:t>Maintain O</a:t>
            </a:r>
            <a:r>
              <a:rPr lang="en-US" baseline="-25000" dirty="0">
                <a:solidFill>
                  <a:schemeClr val="bg1"/>
                </a:solidFill>
              </a:rPr>
              <a:t>2</a:t>
            </a:r>
            <a:r>
              <a:rPr lang="en-US" dirty="0">
                <a:solidFill>
                  <a:schemeClr val="bg1"/>
                </a:solidFill>
              </a:rPr>
              <a:t> sat &gt; 95%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B9174DE-3E89-4D4F-9FA7-455D2759C673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0241049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6C7DDF-0CEA-8C4F-B7C1-AE3D33DA4A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SCHARGE HOME IF…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90E99D-9D5F-064F-A4DC-6ACD0A4612A0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Vitals stabl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Afebril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Tolerating die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Pain is improving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D83D7B3-4D8D-1546-88B7-DA81AB7551D1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304150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A9A956-38B3-824E-B211-E5AFA64B31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LICATIONS </a:t>
            </a:r>
            <a:r>
              <a:rPr lang="en-US" dirty="0">
                <a:sym typeface="Wingdings" pitchFamily="2" charset="2"/>
              </a:rPr>
              <a:t> INDICATIONS FOR INPATIENT ADMISSION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70F852-EC3F-9A4B-A743-3DF39AFF134C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 numCol="2">
            <a:norm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Hemodynamic instabilit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Inability to tolerate PO &gt; 24 h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Intractable abdominal pai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Extrapancreatic infections (ie, urinary track infection, pneumonia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Increasing size of peri-pancreatic fluid collect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Pancreatic pseudocys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Necrotizing pancreatiti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Splanchnic venous thrombosi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Pseudoaneurysm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Abdominal compartment syndrom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Diabetic ketoacidosis 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162B5D4-570F-254A-95B7-2ABE86C68D2E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6358524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F4D1AD-4ED9-FB45-99AA-C9188468E7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E0598A-C2EA-0B43-8557-059CFB7B527E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1. Kasper DL, et al. Pancreatitis. In: </a:t>
            </a:r>
            <a:r>
              <a:rPr lang="en-US" i="1" dirty="0"/>
              <a:t>Harrison’s Manual of Medicine</a:t>
            </a:r>
            <a:r>
              <a:rPr lang="en-US" dirty="0"/>
              <a:t>. 19th ed. The McGraw-Hill Companies; 2016:804-808.</a:t>
            </a:r>
          </a:p>
          <a:p>
            <a:r>
              <a:rPr lang="en-US" dirty="0"/>
              <a:t>2. Vege, SS. Management of Acute Pancreatitis. Uptodate.com. Updated March 8, 2021. Accessed March 12, 2021. Available at: </a:t>
            </a:r>
            <a:r>
              <a:rPr lang="en-US" dirty="0">
                <a:hlinkClick r:id="rId3"/>
              </a:rPr>
              <a:t>https://www.uptodate.com/contents/management-of-acute-pancreatitis</a:t>
            </a:r>
            <a:endParaRPr lang="en-US" dirty="0">
              <a:cs typeface="Arial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C3744B6-0636-9046-B78E-2BA848799341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158992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PRESENTATION OF PANCREATITIS</a:t>
            </a:r>
            <a:endParaRPr lang="en-US" dirty="0">
              <a:solidFill>
                <a:schemeClr val="accent1">
                  <a:lumMod val="20000"/>
                  <a:lumOff val="80000"/>
                </a:schemeClr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>
          <a:xfrm>
            <a:off x="685800" y="2055137"/>
            <a:ext cx="6904038" cy="2634338"/>
          </a:xfrm>
        </p:spPr>
        <p:txBody>
          <a:bodyPr vert="horz" lIns="0" tIns="0" rIns="0" bIns="0" rtlCol="0" anchor="t">
            <a:norm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Acute, severe abdominal pain or back pain</a:t>
            </a:r>
          </a:p>
          <a:p>
            <a:pPr marL="788670" lvl="1" indent="-285750">
              <a:buFont typeface="Arial" charset="0"/>
              <a:buChar char="•"/>
            </a:pPr>
            <a:r>
              <a:rPr lang="en-US" dirty="0"/>
              <a:t>Usually epigastric pain radiating to the back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Most commonly a history of EtOH use or biliary disease with abdominal pain</a:t>
            </a:r>
            <a:endParaRPr lang="en-US" dirty="0"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58360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DDITIONAL SIGNS &amp; SYMPTOMS OF PANCREATITI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>
            <a:normAutofit/>
          </a:bodyPr>
          <a:lstStyle/>
          <a:p>
            <a:pPr marL="285750" indent="-285750">
              <a:buFont typeface="Arial" charset="0"/>
              <a:buChar char="•"/>
            </a:pPr>
            <a:r>
              <a:rPr lang="en-US" dirty="0"/>
              <a:t>Vitals can include…</a:t>
            </a:r>
          </a:p>
          <a:p>
            <a:pPr marL="788670" lvl="1" indent="-285750">
              <a:buFont typeface="Arial" charset="0"/>
              <a:buChar char="•"/>
            </a:pPr>
            <a:r>
              <a:rPr lang="en-US" dirty="0"/>
              <a:t>Fever</a:t>
            </a:r>
          </a:p>
          <a:p>
            <a:pPr marL="788670" lvl="1" indent="-285750">
              <a:buFont typeface="Arial" charset="0"/>
              <a:buChar char="•"/>
            </a:pPr>
            <a:r>
              <a:rPr lang="en-US" dirty="0"/>
              <a:t>Tachycardia</a:t>
            </a:r>
          </a:p>
          <a:p>
            <a:pPr marL="788670" lvl="1" indent="-285750">
              <a:buFont typeface="Arial" charset="0"/>
              <a:buChar char="•"/>
            </a:pPr>
            <a:r>
              <a:rPr lang="en-US" dirty="0"/>
              <a:t>Hypotension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Physical exam notable for…</a:t>
            </a:r>
          </a:p>
          <a:p>
            <a:pPr marL="788670" lvl="1" indent="-285750">
              <a:buFont typeface="Arial" charset="0"/>
              <a:buChar char="•"/>
            </a:pPr>
            <a:r>
              <a:rPr lang="en-US" dirty="0"/>
              <a:t>Abdominal tenderness, usually in epigastrium or LUQ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30603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Oval 5">
            <a:extLst>
              <a:ext uri="{FF2B5EF4-FFF2-40B4-BE49-F238E27FC236}">
                <a16:creationId xmlns:a16="http://schemas.microsoft.com/office/drawing/2014/main" id="{77FA9808-3414-674C-9F8F-859925D15B71}"/>
              </a:ext>
            </a:extLst>
          </p:cNvPr>
          <p:cNvSpPr/>
          <p:nvPr/>
        </p:nvSpPr>
        <p:spPr>
          <a:xfrm>
            <a:off x="5359650" y="1656781"/>
            <a:ext cx="2009869" cy="2037030"/>
          </a:xfrm>
          <a:prstGeom prst="ellipse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5465E8DC-1542-7E44-9259-684B3A4FA6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THER PHYSICAL EXAM FINDINGS TO LOOK OUT FOR…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2A22A2-8C78-1443-B788-BB17A1703BE0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>
            <a:normAutofit fontScale="92500" lnSpcReduction="10000"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Abdominal rigidit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Diminished bowel sound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Palpable upper abdominal mas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Erythematous skin nodules (due to subQ fat necrosis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Basilar rales, left pleural effusion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i="1" dirty="0"/>
              <a:t>Cullen’s sign</a:t>
            </a:r>
            <a:r>
              <a:rPr lang="en-US" dirty="0"/>
              <a:t>: bluish discoloration in the periumbilical region due to hemoperitoneum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i="1" dirty="0"/>
              <a:t>Turner’s sign</a:t>
            </a:r>
            <a:r>
              <a:rPr lang="en-US" dirty="0"/>
              <a:t>: blue-red-purple or greenish-brown discoloration of the flanks due to tissue catabolism of hemoglobin</a:t>
            </a:r>
            <a:endParaRPr lang="en-US" i="1" dirty="0"/>
          </a:p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01AD3D0-CD67-3840-AA37-C6C01D5D5EDB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4</a:t>
            </a:fld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E96FB9F-4AA4-6C4E-B685-055AD0AA2365}"/>
              </a:ext>
            </a:extLst>
          </p:cNvPr>
          <p:cNvSpPr txBox="1"/>
          <p:nvPr/>
        </p:nvSpPr>
        <p:spPr>
          <a:xfrm rot="970379">
            <a:off x="5604094" y="2134347"/>
            <a:ext cx="152098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If seen, NOT</a:t>
            </a:r>
          </a:p>
          <a:p>
            <a:pPr algn="ctr"/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appropriate</a:t>
            </a:r>
          </a:p>
          <a:p>
            <a:pPr algn="ctr"/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for</a:t>
            </a:r>
          </a:p>
          <a:p>
            <a:pPr algn="ctr"/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Observation</a:t>
            </a:r>
          </a:p>
        </p:txBody>
      </p:sp>
    </p:spTree>
    <p:extLst>
      <p:ext uri="{BB962C8B-B14F-4D97-AF65-F5344CB8AC3E}">
        <p14:creationId xmlns:p14="http://schemas.microsoft.com/office/powerpoint/2010/main" val="15996760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2CBF1D-B3DE-5640-9B48-2B77EBF8CD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MON CAUS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853050-56FA-3541-878C-6320F1A7666B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1647731"/>
            <a:ext cx="6904038" cy="3041744"/>
          </a:xfrm>
        </p:spPr>
        <p:txBody>
          <a:bodyPr>
            <a:normAutofit fontScale="92500" lnSpcReduction="10000"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Alcohol us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Gallston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Hypertriglyceridemia </a:t>
            </a: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(NOT appropriate for Observation if TAGs&gt;1000 mg/</a:t>
            </a:r>
            <a:r>
              <a:rPr lang="en-US" dirty="0" err="1">
                <a:solidFill>
                  <a:schemeClr val="accent1">
                    <a:lumMod val="20000"/>
                    <a:lumOff val="80000"/>
                  </a:schemeClr>
                </a:solidFill>
              </a:rPr>
              <a:t>dL</a:t>
            </a: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 </a:t>
            </a: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  <a:sym typeface="Wingdings" pitchFamily="2" charset="2"/>
              </a:rPr>
              <a:t> consider insulin drip in Step Down Unit or MICU</a:t>
            </a: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Recent endoscopic retrograde cholangiopancreatography (ERCP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Postoperative (abdominal and nonabdominal operations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Blunt abdominal trauma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Drugs (Azathioprine, 6-mercaptopurine, sulfonamides, estrogens, Tetracycline, Valproic acid, anti-HIV medications, 5-aminosalicylic acid [5-ASA])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BE3604A-5C3D-F04A-AB01-F065849A5EFC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97533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3343CE-EED3-E44D-8877-696C180270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NOT-SO-COMMON CAUS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4CFE16-AAB4-F048-ABE3-955D5140E2B6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1647731"/>
            <a:ext cx="6904038" cy="3041744"/>
          </a:xfrm>
        </p:spPr>
        <p:txBody>
          <a:bodyPr>
            <a:normAutofit fontScale="70000" lnSpcReduction="20000"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Pancreatic cance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Infections (mumps, coxsackievirus, cytomegalovirus  (CMV), echovirus, parasites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Autoimmun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Cystic fibrosi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Renal failure, Hypercalcemia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Pancreas divisum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Periampullary diverticulum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Hereditar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Vascular causes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Connective tissue disorders and thrombotic thrombocytopenic purpura (TTP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1A198B-AABC-3741-B5B6-BD4A0A5BDF22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6037812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BF1F61-8F97-F44F-A731-4E0E5168D2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FFERENTIAL DIAGNOS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BDA6B6-A87A-0E44-9CCC-EB1935700D05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1665838"/>
            <a:ext cx="6904038" cy="3023637"/>
          </a:xfrm>
        </p:spPr>
        <p:txBody>
          <a:bodyPr>
            <a:normAutofit lnSpcReduction="10000"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Cholecystiti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Renal colic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Aortic dissect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Acute intestinal obstruct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Intestinal perforation, ie, from peptic ulce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Mesenteric occlus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Pneumonia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Inferior MI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F995F6-1898-114A-9286-16346EEE2608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66809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B2E709-2931-4A47-847E-28F5871A89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AB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9AB0E8-9753-F449-93FF-9A2248E79D18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1719938"/>
            <a:ext cx="6973432" cy="2743200"/>
          </a:xfrm>
        </p:spPr>
        <p:txBody>
          <a:bodyPr vert="horz" lIns="0" tIns="0" rIns="0" bIns="0" rtlCol="0" anchor="t">
            <a:norm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Serum </a:t>
            </a:r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lipase</a:t>
            </a: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 level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/>
              <a:t>Preferred test</a:t>
            </a:r>
            <a:endParaRPr lang="en-US" dirty="0">
              <a:cs typeface="Arial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Serum </a:t>
            </a:r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amylase</a:t>
            </a: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 level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/>
              <a:t>Note: normal levels do NOT exclude diagnosis as levels return to normal in 3-7 day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i="1" dirty="0"/>
              <a:t>Leukocytosis, hypocalcemia, hypertriglyceridemia, hyperglycemia, hypoalbuminemia may also be present</a:t>
            </a:r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07CFFED-EBE4-4545-9C30-BE3AE5B05101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2611350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DF6748-DB1D-1244-9FE8-EE3141E335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MAGING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194CDE-42B0-E54F-B784-DA46B8C243A3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>
            <a:norm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CT A/P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/>
              <a:t>Best modality </a:t>
            </a:r>
            <a:r>
              <a:rPr lang="en-US" i="1" dirty="0"/>
              <a:t>but not necessary for diagnosi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Ultrasound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/>
              <a:t>Often difficult to evaluate pancreas due to overlying intestinal gas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/>
              <a:t>If able to be seen, may appreciate edema or pancreatic enlargement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/>
              <a:t>May detect gallstones, pseudocysts, masses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EBA91A9-B6FF-2740-BB6C-BD8966C3599B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88981480"/>
      </p:ext>
    </p:extLst>
  </p:cSld>
  <p:clrMapOvr>
    <a:masterClrMapping/>
  </p:clrMapOvr>
</p:sld>
</file>

<file path=ppt/theme/theme1.xml><?xml version="1.0" encoding="utf-8"?>
<a:theme xmlns:a="http://schemas.openxmlformats.org/drawingml/2006/main" name="NYULMC_160829_16x9-Dark_+Boilerplates">
  <a:themeElements>
    <a:clrScheme name="NYULangone">
      <a:dk1>
        <a:srgbClr val="000000"/>
      </a:dk1>
      <a:lt1>
        <a:srgbClr val="FFFFFF"/>
      </a:lt1>
      <a:dk2>
        <a:srgbClr val="4D4C47"/>
      </a:dk2>
      <a:lt2>
        <a:srgbClr val="EDEDEB"/>
      </a:lt2>
      <a:accent1>
        <a:srgbClr val="580F8B"/>
      </a:accent1>
      <a:accent2>
        <a:srgbClr val="EEA337"/>
      </a:accent2>
      <a:accent3>
        <a:srgbClr val="1C9AD6"/>
      </a:accent3>
      <a:accent4>
        <a:srgbClr val="F15B4E"/>
      </a:accent4>
      <a:accent5>
        <a:srgbClr val="49B6A2"/>
      </a:accent5>
      <a:accent6>
        <a:srgbClr val="99A6CA"/>
      </a:accent6>
      <a:hlink>
        <a:srgbClr val="F47A55"/>
      </a:hlink>
      <a:folHlink>
        <a:srgbClr val="167696"/>
      </a:folHlink>
    </a:clrScheme>
    <a:fontScheme name="NYULangon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NYULangone_082616_16x9-Dark" id="{16CBEE8A-9587-4812-992D-3553C1FB98F7}" vid="{3F59DFCD-48A1-483A-ADCD-1B4B54D76525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E64AEEDD9B7A4D93545ACBE97D4615" ma:contentTypeVersion="2" ma:contentTypeDescription="Create a new document." ma:contentTypeScope="" ma:versionID="f49002b78e3a4a71b814eef46a983816">
  <xsd:schema xmlns:xsd="http://www.w3.org/2001/XMLSchema" xmlns:xs="http://www.w3.org/2001/XMLSchema" xmlns:p="http://schemas.microsoft.com/office/2006/metadata/properties" xmlns:ns2="http://schemas.microsoft.com/sharepoint/v3/fields" targetNamespace="http://schemas.microsoft.com/office/2006/metadata/properties" ma:root="true" ma:fieldsID="38f6db2dd0d9a0cf6a8dc37be32b365b" ns2:_="">
    <xsd:import namespace="http://schemas.microsoft.com/sharepoint/v3/fields"/>
    <xsd:element name="properties">
      <xsd:complexType>
        <xsd:sequence>
          <xsd:element name="documentManagement">
            <xsd:complexType>
              <xsd:all>
                <xsd:element ref="ns2:_Status" minOccurs="0"/>
                <xsd:element ref="ns2:_Vers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/fields" elementFormDefault="qualified">
    <xsd:import namespace="http://schemas.microsoft.com/office/2006/documentManagement/types"/>
    <xsd:import namespace="http://schemas.microsoft.com/office/infopath/2007/PartnerControls"/>
    <xsd:element name="_Status" ma:index="8" nillable="true" ma:displayName="Status" ma:default="Not Started" ma:internalName="_Status">
      <xsd:simpleType>
        <xsd:union memberTypes="dms:Text">
          <xsd:simpleType>
            <xsd:restriction base="dms:Choice">
              <xsd:enumeration value="Not Started"/>
              <xsd:enumeration value="Draft"/>
              <xsd:enumeration value="Reviewed"/>
              <xsd:enumeration value="Scheduled"/>
              <xsd:enumeration value="Published"/>
              <xsd:enumeration value="Final"/>
              <xsd:enumeration value="Expired"/>
            </xsd:restriction>
          </xsd:simpleType>
        </xsd:union>
      </xsd:simpleType>
    </xsd:element>
    <xsd:element name="_Version" ma:index="9" nillable="true" ma:displayName="Version" ma:internalName="_Version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 ma:displayName="Status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Version xmlns="http://schemas.microsoft.com/sharepoint/v3/fields" xsi:nil="true"/>
    <_Status xmlns="http://schemas.microsoft.com/sharepoint/v3/fields">Not Started</_Status>
  </documentManagement>
</p:properties>
</file>

<file path=customXml/itemProps1.xml><?xml version="1.0" encoding="utf-8"?>
<ds:datastoreItem xmlns:ds="http://schemas.openxmlformats.org/officeDocument/2006/customXml" ds:itemID="{87D2A1B0-FF3E-4009-940D-AED0EB70AA20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E4214858-785C-42F7-BE66-6D0E79395FC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/fields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7B6F2769-7194-4217-93D3-3AF3A4742282}">
  <ds:schemaRefs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purl.org/dc/elements/1.1/"/>
    <ds:schemaRef ds:uri="http://schemas.microsoft.com/office/2006/documentManagement/types"/>
    <ds:schemaRef ds:uri="http://purl.org/dc/terms/"/>
    <ds:schemaRef ds:uri="http://schemas.microsoft.com/sharepoint/v3/fields"/>
    <ds:schemaRef ds:uri="http://schemas.microsoft.com/office/2006/metadata/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NYULMC_160829_16x9-Dark</Template>
  <TotalTime>1358</TotalTime>
  <Words>667</Words>
  <Application>Microsoft Macintosh PowerPoint</Application>
  <PresentationFormat>On-screen Show (16:9)</PresentationFormat>
  <Paragraphs>124</Paragraphs>
  <Slides>1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Arial</vt:lpstr>
      <vt:lpstr>Calibri</vt:lpstr>
      <vt:lpstr>Lucida Grande</vt:lpstr>
      <vt:lpstr>Wingdings</vt:lpstr>
      <vt:lpstr>NYULMC_160829_16x9-Dark_+Boilerplates</vt:lpstr>
      <vt:lpstr>AN APPROACH TO pancreatitis in the observation unit</vt:lpstr>
      <vt:lpstr>PRESENTATION OF PANCREATITIS</vt:lpstr>
      <vt:lpstr>ADDITIONAL SIGNS &amp; SYMPTOMS OF PANCREATITIS</vt:lpstr>
      <vt:lpstr>OTHER PHYSICAL EXAM FINDINGS TO LOOK OUT FOR…</vt:lpstr>
      <vt:lpstr>COMMON CAUSES</vt:lpstr>
      <vt:lpstr>NOT-SO-COMMON CAUSES</vt:lpstr>
      <vt:lpstr>DIFFERENTIAL DIAGNOSES</vt:lpstr>
      <vt:lpstr>LABS</vt:lpstr>
      <vt:lpstr>IMAGING</vt:lpstr>
      <vt:lpstr>DIAGNOSIS</vt:lpstr>
      <vt:lpstr>TREATMENT</vt:lpstr>
      <vt:lpstr>DISCHARGE HOME IF…</vt:lpstr>
      <vt:lpstr>COMPLICATIONS  INDICATIONS FOR INPATIENT ADMISSION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DICATION RECONCILIATION</dc:title>
  <dc:creator>Barie Salmon</dc:creator>
  <cp:lastModifiedBy>Alisa Wray</cp:lastModifiedBy>
  <cp:revision>122</cp:revision>
  <dcterms:created xsi:type="dcterms:W3CDTF">2017-06-02T12:45:43Z</dcterms:created>
  <dcterms:modified xsi:type="dcterms:W3CDTF">2021-04-12T18:44:39Z</dcterms:modified>
  <cp:contentStatus>Draft</cp:contentStatus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DE64AEEDD9B7A4D93545ACBE97D4615</vt:lpwstr>
  </property>
</Properties>
</file>